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670675" cy="97520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85AE51-D431-4AAC-93C9-7FCC953DF0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DEEA18-DC04-4A28-88DE-F3D8C965D0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9A2470-0F8B-499F-BDC1-300D586CE03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E6FDE9-4682-47A6-9B50-A23135F0E7C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7297AD-9FFE-4602-BCB9-F15AB688C0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1CE711-2B34-4E53-BEE6-699BFDF14F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81A0DD-E42B-419E-9CA5-1E03857AD1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5AE865-76E9-461D-831B-D5EFB8052A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B51356-1076-4037-8C4A-324ECB5274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A0BA11-94BD-47EC-9960-995DF3A1E3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7BF583-8B9F-4F6F-B52A-4B81D1C132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868EC7-937E-4C97-AF0F-6D6B52FEBD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2AD9C0-F37D-48BC-A755-4263EC92F677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55680" y="1116000"/>
          <a:ext cx="6087960" cy="2193840"/>
        </p:xfrm>
        <a:graphic>
          <a:graphicData uri="http://schemas.openxmlformats.org/drawingml/2006/table">
            <a:tbl>
              <a:tblPr/>
              <a:tblGrid>
                <a:gridCol w="901800"/>
                <a:gridCol w="1371600"/>
                <a:gridCol w="1511280"/>
                <a:gridCol w="1512720"/>
                <a:gridCol w="790560"/>
              </a:tblGrid>
              <a:tr h="262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omplex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C</a:t>
                      </a:r>
                      <a:r>
                        <a:rPr b="0" lang="fr-FR" sz="1000" spc="-1" strike="noStrike" baseline="-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0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± SEM (pM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% Inhibition at 10</a:t>
                      </a:r>
                      <a:r>
                        <a:rPr b="0" lang="fr-FR" sz="10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-12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% Inhibition at 10</a:t>
                      </a:r>
                      <a:r>
                        <a:rPr b="0" lang="fr-FR" sz="10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-7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²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02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α</a:t>
                      </a:r>
                      <a:r>
                        <a:rPr b="0" lang="fr-FR" sz="1000" spc="-1" strike="noStrike" baseline="-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β</a:t>
                      </a:r>
                      <a:r>
                        <a:rPr b="0" lang="fr-FR" sz="1000" spc="-1" strike="noStrike" baseline="-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γ</a:t>
                      </a:r>
                      <a:r>
                        <a:rPr b="0" lang="fr-FR" sz="1000" spc="-1" strike="noStrike" baseline="-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.03 ± 1.5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.5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9.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α</a:t>
                      </a:r>
                      <a:r>
                        <a:rPr b="0" lang="fr-FR" sz="1000" spc="-1" strike="noStrike" baseline="-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β</a:t>
                      </a:r>
                      <a:r>
                        <a:rPr b="0" lang="fr-FR" sz="1000" spc="-1" strike="noStrike" baseline="-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γ</a:t>
                      </a:r>
                      <a:r>
                        <a:rPr b="0" lang="fr-FR" sz="1000" spc="-1" strike="noStrike" baseline="-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41.00 ± 2.2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.7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6.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8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α</a:t>
                      </a:r>
                      <a:r>
                        <a:rPr b="0" lang="fr-FR" sz="1000" spc="-1" strike="noStrike" baseline="-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β</a:t>
                      </a:r>
                      <a:r>
                        <a:rPr b="0" lang="fr-FR" sz="1000" spc="-1" strike="noStrike" baseline="-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γ</a:t>
                      </a:r>
                      <a:r>
                        <a:rPr b="0" lang="fr-FR" sz="1000" spc="-1" strike="noStrike" baseline="-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0.40 ± 0.4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.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4.6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α</a:t>
                      </a:r>
                      <a:r>
                        <a:rPr b="0" lang="fr-FR" sz="1000" spc="-1" strike="noStrike" baseline="-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β</a:t>
                      </a:r>
                      <a:r>
                        <a:rPr b="0" lang="fr-FR" sz="1000" spc="-1" strike="noStrike" baseline="-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γ</a:t>
                      </a:r>
                      <a:r>
                        <a:rPr b="0" lang="fr-FR" sz="1000" spc="-1" strike="noStrike" baseline="-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9.00 ± 0.3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.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3.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7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α</a:t>
                      </a:r>
                      <a:r>
                        <a:rPr b="0" lang="fr-FR" sz="1000" spc="-1" strike="noStrike" baseline="-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β</a:t>
                      </a:r>
                      <a:r>
                        <a:rPr b="0" lang="fr-FR" sz="1000" spc="-1" strike="noStrike" baseline="-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α</a:t>
                      </a:r>
                      <a:r>
                        <a:rPr b="0" lang="fr-FR" sz="1000" spc="-1" strike="noStrike" baseline="-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β</a:t>
                      </a:r>
                      <a:r>
                        <a:rPr b="0" lang="fr-FR" sz="1000" spc="-1" strike="noStrike" baseline="-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β</a:t>
                      </a:r>
                      <a:r>
                        <a:rPr b="0" lang="fr-FR" sz="1000" spc="-1" strike="noStrike" baseline="-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γ</a:t>
                      </a:r>
                      <a:r>
                        <a:rPr b="0" lang="fr-FR" sz="1000" spc="-1" strike="noStrike" baseline="-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66.00 ± 0.7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.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8.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8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20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β</a:t>
                      </a:r>
                      <a:r>
                        <a:rPr b="0" lang="fr-FR" sz="1000" spc="-1" strike="noStrike" baseline="-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γ</a:t>
                      </a:r>
                      <a:r>
                        <a:rPr b="0" lang="fr-FR" sz="1000" spc="-1" strike="noStrike" baseline="-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9.40 ± 0.95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3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8.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Rectangle 116"/>
          <p:cNvSpPr/>
          <p:nvPr/>
        </p:nvSpPr>
        <p:spPr>
          <a:xfrm>
            <a:off x="0" y="600084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81"/>
          <p:cNvSpPr/>
          <p:nvPr/>
        </p:nvSpPr>
        <p:spPr>
          <a:xfrm>
            <a:off x="5348160" y="8520120"/>
            <a:ext cx="1905120" cy="56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Tabl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Desrues 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et a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27T12:43:28Z</dcterms:created>
  <dc:creator>hcastel</dc:creator>
  <dc:description/>
  <dc:language>en-US</dc:language>
  <cp:lastModifiedBy>Helene</cp:lastModifiedBy>
  <dcterms:modified xsi:type="dcterms:W3CDTF">2012-04-06T08:32:28Z</dcterms:modified>
  <cp:revision>141</cp:revision>
  <dc:subject/>
  <dc:title>Diapositive 1</dc:title>
</cp:coreProperties>
</file>